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>
        <p:scale>
          <a:sx n="80" d="100"/>
          <a:sy n="80" d="100"/>
        </p:scale>
        <p:origin x="3060" y="1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780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5153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02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4099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7831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073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2540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8188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6721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4110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331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68F93-E689-4E6E-83B0-21C4DEA7C519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4B65D-BDA2-4F77-A852-C24EE46B4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742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576470" y="560316"/>
            <a:ext cx="5915770" cy="4810790"/>
            <a:chOff x="576470" y="560316"/>
            <a:chExt cx="5915770" cy="4810790"/>
          </a:xfrm>
        </p:grpSpPr>
        <p:sp>
          <p:nvSpPr>
            <p:cNvPr id="6" name="Textfeld 101"/>
            <p:cNvSpPr txBox="1"/>
            <p:nvPr/>
          </p:nvSpPr>
          <p:spPr>
            <a:xfrm>
              <a:off x="2070883" y="4684162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NTC</a:t>
              </a:r>
            </a:p>
          </p:txBody>
        </p:sp>
        <p:sp>
          <p:nvSpPr>
            <p:cNvPr id="7" name="Textfeld 101"/>
            <p:cNvSpPr txBox="1"/>
            <p:nvPr/>
          </p:nvSpPr>
          <p:spPr>
            <a:xfrm>
              <a:off x="2295256" y="4684162"/>
              <a:ext cx="8763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rs277627</a:t>
              </a:r>
              <a:r>
                <a:rPr lang="de-DE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 l="26476" t="15135" r="55126" b="57851"/>
            <a:stretch/>
          </p:blipFill>
          <p:spPr>
            <a:xfrm>
              <a:off x="825664" y="560316"/>
              <a:ext cx="5462803" cy="4070555"/>
            </a:xfrm>
            <a:prstGeom prst="rect">
              <a:avLst/>
            </a:prstGeom>
            <a:ln>
              <a:noFill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778391" y="3533379"/>
              <a:ext cx="995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25664" y="3720628"/>
              <a:ext cx="995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25664" y="3230714"/>
              <a:ext cx="995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01"/>
            <p:cNvSpPr txBox="1"/>
            <p:nvPr/>
          </p:nvSpPr>
          <p:spPr>
            <a:xfrm>
              <a:off x="3304660" y="4684162"/>
              <a:ext cx="241232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-1: NTC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-9: rs277627-/-</a:t>
              </a:r>
            </a:p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-1 and 3-2: other single clones where the deletion did not contain the expected size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76470" y="2814762"/>
              <a:ext cx="5915770" cy="25563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768557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9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ávia Rezende</dc:creator>
  <cp:lastModifiedBy>Flávia Rezende</cp:lastModifiedBy>
  <cp:revision>1</cp:revision>
  <dcterms:created xsi:type="dcterms:W3CDTF">2025-07-16T09:51:58Z</dcterms:created>
  <dcterms:modified xsi:type="dcterms:W3CDTF">2025-07-16T09:57:05Z</dcterms:modified>
</cp:coreProperties>
</file>